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 varScale="1">
        <p:scale>
          <a:sx n="80" d="100"/>
          <a:sy n="80" d="100"/>
        </p:scale>
        <p:origin x="61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77985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304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103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09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2829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1654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0468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2551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57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9283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455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A0122B-8D88-4B02-9A9A-B9228F0B7318}" type="datetimeFigureOut">
              <a:rPr lang="fr-FR" smtClean="0"/>
              <a:t>11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E5BBB7-292B-4B07-992B-21DFBA5BE5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84211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CECCE0D-130B-4D79-97F8-BC119032B6FA}"/>
              </a:ext>
            </a:extLst>
          </p:cNvPr>
          <p:cNvSpPr txBox="1"/>
          <p:nvPr/>
        </p:nvSpPr>
        <p:spPr>
          <a:xfrm>
            <a:off x="273974" y="507419"/>
            <a:ext cx="6033838" cy="4788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processed S5 Fig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Red rectangles indicate the cropped images shown in the respective manuscript figures.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1" name="Picture 6" descr="A picture containing text, screenshot, line, diagram&#10;&#10;Description automatically generated">
            <a:extLst>
              <a:ext uri="{FF2B5EF4-FFF2-40B4-BE49-F238E27FC236}">
                <a16:creationId xmlns:a16="http://schemas.microsoft.com/office/drawing/2014/main" id="{DD654F08-B78A-4E14-9C78-8A26B388333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010" y="1758014"/>
            <a:ext cx="5935980" cy="447294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2530327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7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allois Jean-Luc</dc:creator>
  <cp:lastModifiedBy>Gallois Jean-Luc</cp:lastModifiedBy>
  <cp:revision>6</cp:revision>
  <dcterms:created xsi:type="dcterms:W3CDTF">2023-09-11T13:58:36Z</dcterms:created>
  <dcterms:modified xsi:type="dcterms:W3CDTF">2023-09-11T14:06:14Z</dcterms:modified>
</cp:coreProperties>
</file>